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jp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8" r:id="rId2"/>
    <p:sldId id="259" r:id="rId3"/>
    <p:sldId id="256" r:id="rId4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10"/>
    <p:restoredTop sz="94656"/>
  </p:normalViewPr>
  <p:slideViewPr>
    <p:cSldViewPr snapToGrid="0" snapToObjects="1">
      <p:cViewPr varScale="1">
        <p:scale>
          <a:sx n="62" d="100"/>
          <a:sy n="62" d="100"/>
        </p:scale>
        <p:origin x="804" y="5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B85B889-3677-D34D-9B7E-8FB4A645763D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C765E150-481F-434A-9513-5BFE8F843E8A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940849B-7C2C-3E44-9076-4AB732118E4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45A658-4955-EE45-ACB3-3CEA3B55B841}" type="datetimeFigureOut">
              <a:rPr lang="en-US" smtClean="0"/>
              <a:t>6/9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4147B97-D58F-A344-A95A-C3B620857B2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EE2E65F-0065-1D42-84DD-2EED829EC9C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FA55A6-F835-6F43-9CB0-48F82D66D8C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7354224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B027619-1C7D-1847-9451-9E7E5B862FF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F64DCEA5-4266-DD4F-9A24-A3DD6872D82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CD6FFD6-0181-5145-B9CC-304ED724FDB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45A658-4955-EE45-ACB3-3CEA3B55B841}" type="datetimeFigureOut">
              <a:rPr lang="en-US" smtClean="0"/>
              <a:t>6/9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C1423D9-FCB0-6349-B9AB-46C0923A72B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14A3190-45F5-534C-8002-9900C4F7D43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FA55A6-F835-6F43-9CB0-48F82D66D8C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3758033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0BE8990F-F849-3F4A-83BC-3C70F497174A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D74EDDB9-EA3B-FD44-8814-47E5DF96028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233E00D-856A-4745-9098-D892C0DFDF6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45A658-4955-EE45-ACB3-3CEA3B55B841}" type="datetimeFigureOut">
              <a:rPr lang="en-US" smtClean="0"/>
              <a:t>6/9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F5B0A39-5936-1945-8E2A-B539AA34590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3394951-0572-E247-9BB3-B10EB1B15FA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FA55A6-F835-6F43-9CB0-48F82D66D8C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284022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55CC3FF-85C3-3649-B56E-F5D2A1D72F2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ABB0929-E8F9-5D42-A580-2524C8891035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D1A4241-1506-FE42-98D1-E3A9CB6D8D2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45A658-4955-EE45-ACB3-3CEA3B55B841}" type="datetimeFigureOut">
              <a:rPr lang="en-US" smtClean="0"/>
              <a:t>6/9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CB7B749-E4D2-8947-A23B-14A3B079207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6192F1E-E40C-234F-B059-BCC847BC161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FA55A6-F835-6F43-9CB0-48F82D66D8C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6497818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3A8861E-B13D-3A49-8F50-4F2CB810EE0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8311B16-8DBF-E647-8005-477B799AE7C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82D38C9-7ABA-C540-8226-BB62397231D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45A658-4955-EE45-ACB3-3CEA3B55B841}" type="datetimeFigureOut">
              <a:rPr lang="en-US" smtClean="0"/>
              <a:t>6/9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920A2E8-108E-A84E-B31B-62AE4A8D3D4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8BFB523-D4A9-6C49-9A9C-87032FB665F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FA55A6-F835-6F43-9CB0-48F82D66D8C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057855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7281E5D-7567-C544-A7F1-D1D6F7EC194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026A34D-B401-6A40-A05E-194010996964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C1C5E6CD-B923-E545-B57A-CACCD97C024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3AD1621-B156-E841-8CFE-2E776E1B01E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45A658-4955-EE45-ACB3-3CEA3B55B841}" type="datetimeFigureOut">
              <a:rPr lang="en-US" smtClean="0"/>
              <a:t>6/9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F5CF46D-B1FD-0A40-B0B2-D995F502B3C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B56B3DF-68E3-B346-8294-A3151FFB2D5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FA55A6-F835-6F43-9CB0-48F82D66D8C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0725958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E231E00-62AE-E040-A8AF-870075D4BE6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C1C5A48-655A-634D-8110-24D5E9D80CD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7C2719D3-6A24-FC42-A938-72B2BD96D9A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F583EBFB-85CA-C747-A821-B8CACDCBF123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CF733CD6-485C-4D46-91EC-6F00FBA223A6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CB13A069-0C0A-C240-BE32-32D67582DE9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45A658-4955-EE45-ACB3-3CEA3B55B841}" type="datetimeFigureOut">
              <a:rPr lang="en-US" smtClean="0"/>
              <a:t>6/9/2022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2F032961-B50B-B54A-837E-D554F5925F1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EF4D8CE8-E389-2E4C-A6E3-9FD953724BD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FA55A6-F835-6F43-9CB0-48F82D66D8C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4139288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62A6837-B08E-5B4F-98FC-43235A7827A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EE611733-C69E-B24C-BBFD-74D807BA34C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45A658-4955-EE45-ACB3-3CEA3B55B841}" type="datetimeFigureOut">
              <a:rPr lang="en-US" smtClean="0"/>
              <a:t>6/9/2022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15CF197D-8EBF-0946-B7F1-7C08800351B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1E8392B6-1F7A-5945-B8E6-2BFEBD0DCBB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FA55A6-F835-6F43-9CB0-48F82D66D8C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4069200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2F6D9228-B97F-C74B-B260-9FBE51E22DD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45A658-4955-EE45-ACB3-3CEA3B55B841}" type="datetimeFigureOut">
              <a:rPr lang="en-US" smtClean="0"/>
              <a:t>6/9/2022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B4BE7E04-DF2C-9F49-A0D1-B3B3C31244A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5385AB1F-8816-0B48-8538-017D60FFE44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FA55A6-F835-6F43-9CB0-48F82D66D8C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8439363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BF5F0EC-E6E9-E24F-8689-55EFCA9F884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8F5A759-E4BE-954E-9669-2E851A14756D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5AD784CB-CE95-9B4D-8AD0-E252B5DDEAB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86E7CB0-9EE1-854A-8519-0B9826961B5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45A658-4955-EE45-ACB3-3CEA3B55B841}" type="datetimeFigureOut">
              <a:rPr lang="en-US" smtClean="0"/>
              <a:t>6/9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6FF871A-CC89-DC4D-8124-4E2E329B0FC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6B08CE6-F659-1E4F-A239-D57E50EBC02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FA55A6-F835-6F43-9CB0-48F82D66D8C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1193830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A23863D-A8EE-A443-B767-9CF7436D768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5CA56FB7-DB36-3C4E-B876-140A135E52A3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54585174-3330-E247-8444-B2D1D6477A4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CCDE38C-8DB9-F448-882B-C69296136D8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45A658-4955-EE45-ACB3-3CEA3B55B841}" type="datetimeFigureOut">
              <a:rPr lang="en-US" smtClean="0"/>
              <a:t>6/9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9B461B0-7F8F-7340-9D66-177A3FB52E4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8444BEF-0DC2-7644-BB3A-39E0C4DEC43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FA55A6-F835-6F43-9CB0-48F82D66D8C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4855157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C5AECA89-313F-6E4F-8C4C-2DB46FCF97A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189F66C-A713-FB40-8479-BFDA087D58B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133D40B-8F66-3F4A-A72A-7362A28CF3EE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645A658-4955-EE45-ACB3-3CEA3B55B841}" type="datetimeFigureOut">
              <a:rPr lang="en-US" smtClean="0"/>
              <a:t>6/9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C8111FA-BA88-9E43-9D8E-AA4EE78D3B5C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E189B08-92C3-2E46-8D1C-EA28BB162472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AFA55A6-F835-6F43-9CB0-48F82D66D8C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8135145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2" Type="http://schemas.openxmlformats.org/officeDocument/2006/relationships/image" Target="../media/image3.jp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46864413-74F5-B847-8C17-DA625EE81C3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173566"/>
            <a:ext cx="12192000" cy="6510867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B7C62CDC-5BDF-5C41-9BC5-803A349C3710}"/>
              </a:ext>
            </a:extLst>
          </p:cNvPr>
          <p:cNvSpPr txBox="1"/>
          <p:nvPr/>
        </p:nvSpPr>
        <p:spPr>
          <a:xfrm>
            <a:off x="871975" y="273133"/>
            <a:ext cx="9366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Figure 6</a:t>
            </a:r>
          </a:p>
        </p:txBody>
      </p:sp>
    </p:spTree>
    <p:extLst>
      <p:ext uri="{BB962C8B-B14F-4D97-AF65-F5344CB8AC3E}">
        <p14:creationId xmlns:p14="http://schemas.microsoft.com/office/powerpoint/2010/main" val="108527488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D4173E56-9556-2A47-81DF-69973AB9DB14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37598" t="30894" r="38344" b="49590"/>
          <a:stretch/>
        </p:blipFill>
        <p:spPr>
          <a:xfrm>
            <a:off x="3325091" y="273133"/>
            <a:ext cx="4797302" cy="2078181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C726458B-44C2-F740-856E-1B19637572E1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r="39323" b="47184"/>
          <a:stretch/>
        </p:blipFill>
        <p:spPr>
          <a:xfrm rot="179737" flipH="1">
            <a:off x="961556" y="3120707"/>
            <a:ext cx="3859536" cy="3529201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C392CE3F-C0F4-394E-A7DF-92F136C0B328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59775" b="47184"/>
          <a:stretch/>
        </p:blipFill>
        <p:spPr>
          <a:xfrm>
            <a:off x="6770251" y="3018493"/>
            <a:ext cx="2704284" cy="3729853"/>
          </a:xfrm>
          <a:prstGeom prst="rect">
            <a:avLst/>
          </a:prstGeom>
        </p:spPr>
      </p:pic>
      <p:sp>
        <p:nvSpPr>
          <p:cNvPr id="8" name="Rectangle 7">
            <a:extLst>
              <a:ext uri="{FF2B5EF4-FFF2-40B4-BE49-F238E27FC236}">
                <a16:creationId xmlns:a16="http://schemas.microsoft.com/office/drawing/2014/main" id="{79E08B8C-14E6-AB4F-9B84-60D92E7287BA}"/>
              </a:ext>
            </a:extLst>
          </p:cNvPr>
          <p:cNvSpPr/>
          <p:nvPr/>
        </p:nvSpPr>
        <p:spPr>
          <a:xfrm rot="196858">
            <a:off x="1520042" y="4191990"/>
            <a:ext cx="2505693" cy="693317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10" name="Straight Arrow Connector 9">
            <a:extLst>
              <a:ext uri="{FF2B5EF4-FFF2-40B4-BE49-F238E27FC236}">
                <a16:creationId xmlns:a16="http://schemas.microsoft.com/office/drawing/2014/main" id="{92FF9049-2C21-1443-A738-920E83D26CD9}"/>
              </a:ext>
            </a:extLst>
          </p:cNvPr>
          <p:cNvCxnSpPr/>
          <p:nvPr/>
        </p:nvCxnSpPr>
        <p:spPr>
          <a:xfrm flipH="1">
            <a:off x="2412694" y="1476260"/>
            <a:ext cx="2721166" cy="2644594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" name="Straight Arrow Connector 11">
            <a:extLst>
              <a:ext uri="{FF2B5EF4-FFF2-40B4-BE49-F238E27FC236}">
                <a16:creationId xmlns:a16="http://schemas.microsoft.com/office/drawing/2014/main" id="{4E5A2851-E5E9-6340-B7D9-4E02A64E9B10}"/>
              </a:ext>
            </a:extLst>
          </p:cNvPr>
          <p:cNvCxnSpPr/>
          <p:nvPr/>
        </p:nvCxnSpPr>
        <p:spPr>
          <a:xfrm>
            <a:off x="7182998" y="2214390"/>
            <a:ext cx="561860" cy="2478796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" name="Rectangle 12">
            <a:extLst>
              <a:ext uri="{FF2B5EF4-FFF2-40B4-BE49-F238E27FC236}">
                <a16:creationId xmlns:a16="http://schemas.microsoft.com/office/drawing/2014/main" id="{4A8A53FD-1914-B040-9BBC-5C26A7C4BDC8}"/>
              </a:ext>
            </a:extLst>
          </p:cNvPr>
          <p:cNvSpPr/>
          <p:nvPr/>
        </p:nvSpPr>
        <p:spPr>
          <a:xfrm>
            <a:off x="7072829" y="4883419"/>
            <a:ext cx="1597446" cy="404677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8FC9580A-75AD-7747-BB54-C77ED0669CBA}"/>
              </a:ext>
            </a:extLst>
          </p:cNvPr>
          <p:cNvSpPr txBox="1"/>
          <p:nvPr/>
        </p:nvSpPr>
        <p:spPr>
          <a:xfrm>
            <a:off x="871975" y="273133"/>
            <a:ext cx="1350819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dirty="0"/>
              <a:t>Figure 6B</a:t>
            </a:r>
          </a:p>
        </p:txBody>
      </p:sp>
    </p:spTree>
    <p:extLst>
      <p:ext uri="{BB962C8B-B14F-4D97-AF65-F5344CB8AC3E}">
        <p14:creationId xmlns:p14="http://schemas.microsoft.com/office/powerpoint/2010/main" val="372509435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24E4843B-A5F0-5C45-B27B-D88B1BC05679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b="57934"/>
          <a:stretch/>
        </p:blipFill>
        <p:spPr>
          <a:xfrm>
            <a:off x="7338197" y="2446022"/>
            <a:ext cx="4415084" cy="2785888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3BCA2F1A-7BB9-D24F-8FA4-F06D5D1218F1}"/>
              </a:ext>
            </a:extLst>
          </p:cNvPr>
          <p:cNvSpPr txBox="1"/>
          <p:nvPr/>
        </p:nvSpPr>
        <p:spPr>
          <a:xfrm>
            <a:off x="1152395" y="325677"/>
            <a:ext cx="1347613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dirty="0"/>
              <a:t>Figure 6C</a:t>
            </a: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F3FD3212-9962-344A-AC74-CDC986573263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36325" t="72632" r="38012"/>
          <a:stretch/>
        </p:blipFill>
        <p:spPr>
          <a:xfrm>
            <a:off x="217170" y="1600219"/>
            <a:ext cx="5644569" cy="3214727"/>
          </a:xfrm>
          <a:prstGeom prst="rect">
            <a:avLst/>
          </a:prstGeom>
        </p:spPr>
      </p:pic>
      <p:cxnSp>
        <p:nvCxnSpPr>
          <p:cNvPr id="3" name="Straight Arrow Connector 2">
            <a:extLst>
              <a:ext uri="{FF2B5EF4-FFF2-40B4-BE49-F238E27FC236}">
                <a16:creationId xmlns:a16="http://schemas.microsoft.com/office/drawing/2014/main" id="{0797A55E-3FA1-6542-8A7A-E8093037F907}"/>
              </a:ext>
            </a:extLst>
          </p:cNvPr>
          <p:cNvCxnSpPr/>
          <p:nvPr/>
        </p:nvCxnSpPr>
        <p:spPr>
          <a:xfrm>
            <a:off x="5609100" y="3415229"/>
            <a:ext cx="1355075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" name="Straight Arrow Connector 6">
            <a:extLst>
              <a:ext uri="{FF2B5EF4-FFF2-40B4-BE49-F238E27FC236}">
                <a16:creationId xmlns:a16="http://schemas.microsoft.com/office/drawing/2014/main" id="{C3258AF6-8DDF-E94B-BB45-6A7A790EB11B}"/>
              </a:ext>
            </a:extLst>
          </p:cNvPr>
          <p:cNvCxnSpPr/>
          <p:nvPr/>
        </p:nvCxnSpPr>
        <p:spPr>
          <a:xfrm>
            <a:off x="5563379" y="4361257"/>
            <a:ext cx="1355075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" name="TextBox 7">
            <a:extLst>
              <a:ext uri="{FF2B5EF4-FFF2-40B4-BE49-F238E27FC236}">
                <a16:creationId xmlns:a16="http://schemas.microsoft.com/office/drawing/2014/main" id="{0351BA93-0297-EE49-9B8B-39E69EA92820}"/>
              </a:ext>
            </a:extLst>
          </p:cNvPr>
          <p:cNvSpPr txBox="1"/>
          <p:nvPr/>
        </p:nvSpPr>
        <p:spPr>
          <a:xfrm>
            <a:off x="7421365" y="1793323"/>
            <a:ext cx="3997120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We could find only the trimmed images, </a:t>
            </a:r>
          </a:p>
          <a:p>
            <a:r>
              <a:rPr lang="en-US" dirty="0"/>
              <a:t>not the full blots</a:t>
            </a:r>
          </a:p>
        </p:txBody>
      </p:sp>
    </p:spTree>
    <p:extLst>
      <p:ext uri="{BB962C8B-B14F-4D97-AF65-F5344CB8AC3E}">
        <p14:creationId xmlns:p14="http://schemas.microsoft.com/office/powerpoint/2010/main" val="73243421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8</Words>
  <Application>Microsoft Office PowerPoint</Application>
  <PresentationFormat>Widescreen</PresentationFormat>
  <Paragraphs>5</Paragraphs>
  <Slides>3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7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imple Notani</dc:creator>
  <cp:lastModifiedBy>Alice Coles-Aldridge</cp:lastModifiedBy>
  <cp:revision>8</cp:revision>
  <dcterms:created xsi:type="dcterms:W3CDTF">2021-12-06T16:40:40Z</dcterms:created>
  <dcterms:modified xsi:type="dcterms:W3CDTF">2022-06-09T14:03:19Z</dcterms:modified>
</cp:coreProperties>
</file>